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338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925108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538225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4765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53218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42135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69595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48125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96292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1009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7065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7A9139-5C6D-4F74-8CAE-9DD751791D1E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CD0E98-9924-4EDB-80D5-5C58626EEA8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1467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Rectangle 1"/>
          <p:cNvSpPr>
            <a:spLocks noChangeArrowheads="1"/>
          </p:cNvSpPr>
          <p:nvPr/>
        </p:nvSpPr>
        <p:spPr bwMode="auto">
          <a:xfrm>
            <a:off x="304800" y="457202"/>
            <a:ext cx="47244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S1 Table. </a:t>
            </a:r>
            <a:r>
              <a:rPr lang="en-US" sz="1200" b="1" dirty="0" err="1">
                <a:solidFill>
                  <a:prstClr val="black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Oligonucleotides</a:t>
            </a:r>
            <a:r>
              <a:rPr lang="en-US" sz="1200" b="1" dirty="0">
                <a:solidFill>
                  <a:prstClr val="black"/>
                </a:solidFill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used in vector construction. </a:t>
            </a: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304800" y="990600"/>
          <a:ext cx="6172200" cy="6858000"/>
        </p:xfrm>
        <a:graphic>
          <a:graphicData uri="http://schemas.openxmlformats.org/drawingml/2006/table">
            <a:tbl>
              <a:tblPr/>
              <a:tblGrid>
                <a:gridCol w="1345223"/>
                <a:gridCol w="4826977"/>
              </a:tblGrid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Name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Sequence (5' → 3')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RbcSTPXba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ATT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TCTAGA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GCTTCCTCTATGCTCTCTT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latin typeface="Times New Roman"/>
                          <a:ea typeface="SimSun"/>
                          <a:cs typeface="Times New Roman"/>
                        </a:rPr>
                        <a:t>RbcSTPKpnBamHR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TATT</a:t>
                      </a:r>
                      <a:r>
                        <a:rPr lang="en-US" sz="1200" b="1" i="1" u="sng" dirty="0">
                          <a:latin typeface="Times New Roman"/>
                          <a:ea typeface="SimSun"/>
                          <a:cs typeface="Times New Roman"/>
                        </a:rPr>
                        <a:t>GGATCCGGTACC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GGAATCGGTAAGGTCAGGAAG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LSTPXba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CTAG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TCTAGA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GTTTCAATATTGAGTAACAT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LSTPKpnBamH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TT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GGATCCGGTACC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GAAATAGGATGTGAGTGCTTAG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SaSSyKpn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AT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GGTACC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GACTCGTCGACCGCCA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SaSSyBamH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TAA</a:t>
                      </a:r>
                      <a:r>
                        <a:rPr lang="en-US" sz="1200" b="1" i="1" u="sng" dirty="0">
                          <a:latin typeface="Times New Roman"/>
                          <a:ea typeface="SimSun"/>
                          <a:cs typeface="Times New Roman"/>
                        </a:rPr>
                        <a:t>GGATCC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AACTCCTCGCCGAGGGGGATG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PSKpn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TAA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GGTACC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AGTGTGAGTTGTTGTTGTAG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PSBamh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AATT</a:t>
                      </a:r>
                      <a:r>
                        <a:rPr lang="en-US" sz="1200" b="1" i="1" u="sng" dirty="0">
                          <a:latin typeface="Times New Roman"/>
                          <a:ea typeface="SimSun"/>
                          <a:cs typeface="Times New Roman"/>
                        </a:rPr>
                        <a:t>GGATCC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TCCTTCTGCCTCTTGTAGAT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PSXba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GCC</a:t>
                      </a:r>
                      <a:r>
                        <a:rPr lang="en-US" sz="1200" b="1" i="1" u="sng" dirty="0">
                          <a:latin typeface="Times New Roman"/>
                          <a:ea typeface="SimSun"/>
                          <a:cs typeface="Times New Roman"/>
                        </a:rPr>
                        <a:t>TCTAGA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ATGAGTGTGAGTTGTTGTTG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FPSAsc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T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GGCGCGCC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CTTCTGCCTCTTGTAGAT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SaSSyXba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AT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TCTAGA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GACTCGTCGACCGCCA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RbcSPPst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GC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CTGCAG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TTCAATTAAAAGTGCATGATAT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RbcSPAvr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CGT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CCTAGG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GTTCTTCTTTACTCTTTGTGT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HMGRBamH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CA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GGATCC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AAGAAAAAGCAAGCTGGT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HMGRXba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GA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TCTAGA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CATGTTGTTGTTGTTGTCGTTG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HMGRBamH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CA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GGATCC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GATCTCCGTCGGAGGC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4864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HMGR-BP-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GGGACAAGTTTGTACAAAAAAGCAGGCT</a:t>
                      </a:r>
                    </a:p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CATGAAGAAAAAGCAAGCTGGTCC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4864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HMGR-BP-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GGGACCACTTTGTACAAGAAAGCTGGGTC</a:t>
                      </a:r>
                    </a:p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TCATGTTGTTGTTGTTGTCGT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4864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latin typeface="Times New Roman"/>
                          <a:ea typeface="SimSun"/>
                          <a:cs typeface="Times New Roman"/>
                        </a:rPr>
                        <a:t>tHMGR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-BP-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GGGACAAGTTTGTACAAAAAAGCAGGCTT</a:t>
                      </a:r>
                    </a:p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CATGGATCTCCGTCGGAGGC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>
                          <a:latin typeface="Times New Roman"/>
                          <a:ea typeface="SimSun"/>
                          <a:cs typeface="Times New Roman"/>
                        </a:rPr>
                        <a:t>F39v1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vrF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CCG</a:t>
                      </a:r>
                      <a:r>
                        <a:rPr lang="en-US" sz="1200" b="1" i="1" u="sng">
                          <a:latin typeface="Times New Roman"/>
                          <a:ea typeface="SimSun"/>
                          <a:cs typeface="Times New Roman"/>
                        </a:rPr>
                        <a:t>CCTAGG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GGACTTCTTAAGTTGTATC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74320"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>
                          <a:latin typeface="Times New Roman"/>
                          <a:ea typeface="SimSun"/>
                          <a:cs typeface="Times New Roman"/>
                        </a:rPr>
                        <a:t>F39v1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XohR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l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GTAA</a:t>
                      </a:r>
                      <a:r>
                        <a:rPr lang="en-US" sz="1200" b="1" i="1" u="sng" dirty="0">
                          <a:latin typeface="Times New Roman"/>
                          <a:ea typeface="SimSun"/>
                          <a:cs typeface="Times New Roman"/>
                        </a:rPr>
                        <a:t>CTCGAG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TTACCCCCGGATTGGGACAGC</a:t>
                      </a:r>
                    </a:p>
                  </a:txBody>
                  <a:tcPr marL="22412" marR="2241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86056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4</Words>
  <Application>Microsoft Office PowerPoint</Application>
  <PresentationFormat>全屏显示(4:3)</PresentationFormat>
  <Paragraphs>4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1</cp:revision>
  <dcterms:created xsi:type="dcterms:W3CDTF">2018-12-27T07:43:35Z</dcterms:created>
  <dcterms:modified xsi:type="dcterms:W3CDTF">2018-12-27T07:45:17Z</dcterms:modified>
</cp:coreProperties>
</file>